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png" ContentType="image/png"/>
  <Override PartName="/ppt/media/image6.wmf" ContentType="image/x-wmf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9520" y="741240"/>
            <a:ext cx="2778120" cy="3702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D6FAE8-3626-443A-97B6-FF1B75F0475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sldImg"/>
          </p:nvPr>
        </p:nvSpPr>
        <p:spPr>
          <a:xfrm>
            <a:off x="2009880" y="741240"/>
            <a:ext cx="2778120" cy="3702240"/>
          </a:xfrm>
          <a:prstGeom prst="rect">
            <a:avLst/>
          </a:prstGeom>
          <a:ln w="0">
            <a:noFill/>
          </a:ln>
        </p:spPr>
      </p:sp>
      <p:sp>
        <p:nvSpPr>
          <p:cNvPr id="229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Espace réservé du numéro de diapositive 3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F7DEF5-3A76-49DB-B215-3BF8798046F4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sldImg"/>
          </p:nvPr>
        </p:nvSpPr>
        <p:spPr>
          <a:xfrm>
            <a:off x="2009880" y="741240"/>
            <a:ext cx="2778120" cy="3702240"/>
          </a:xfrm>
          <a:prstGeom prst="rect">
            <a:avLst/>
          </a:prstGeom>
          <a:ln w="0">
            <a:noFill/>
          </a:ln>
        </p:spPr>
      </p:sp>
      <p:sp>
        <p:nvSpPr>
          <p:cNvPr id="232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Espace réservé du numéro de diapositive 3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219AC7-10F1-4788-9F59-167F2457C11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ldImg"/>
          </p:nvPr>
        </p:nvSpPr>
        <p:spPr>
          <a:xfrm>
            <a:off x="2009880" y="741240"/>
            <a:ext cx="2778120" cy="3702240"/>
          </a:xfrm>
          <a:prstGeom prst="rect">
            <a:avLst/>
          </a:prstGeom>
          <a:ln w="0">
            <a:noFill/>
          </a:ln>
        </p:spPr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Espace réservé du numéro de diapositive 3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BD2497-C57C-4D87-8CEE-A9147CC80E89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A5C34-460D-41DC-9190-C69B11EB1E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B2D0D-9688-4709-B10B-5E8AB1C80D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40E5C-3620-4206-A34C-2B72D8C510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4539A-D94A-4A11-907F-CDB96531E9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DA6B6-BAEA-42AB-9A6B-9498AFD7E6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63219-D8D4-4FD6-96A5-1435D54A6C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0046C-70FB-4512-8C9E-B9C5F7CBDC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7D7F4-0449-4981-91E6-498CC7FC29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E39C7-D02E-405B-AF7C-BD046EC62D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6BAEC-4C89-42FC-82EC-DF92B65BA8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E2603-E40B-4854-B803-4842129BDC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F9B0A-0428-4EE2-92A1-5BBBE8ECA9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D537B8-DB96-4F51-8461-C145AEE5DF2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8.png"/><Relationship Id="rId11" Type="http://schemas.openxmlformats.org/officeDocument/2006/relationships/image" Target="../media/image19.png"/><Relationship Id="rId12" Type="http://schemas.openxmlformats.org/officeDocument/2006/relationships/image" Target="../media/image20.png"/><Relationship Id="rId13" Type="http://schemas.openxmlformats.org/officeDocument/2006/relationships/image" Target="../media/image21.png"/><Relationship Id="rId14" Type="http://schemas.openxmlformats.org/officeDocument/2006/relationships/image" Target="../media/image22.png"/><Relationship Id="rId15" Type="http://schemas.openxmlformats.org/officeDocument/2006/relationships/image" Target="../media/image23.png"/><Relationship Id="rId16" Type="http://schemas.openxmlformats.org/officeDocument/2006/relationships/image" Target="../media/image24.png"/><Relationship Id="rId17" Type="http://schemas.openxmlformats.org/officeDocument/2006/relationships/image" Target="../media/image25.png"/><Relationship Id="rId18" Type="http://schemas.openxmlformats.org/officeDocument/2006/relationships/image" Target="../media/image26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20"/>
          <p:cNvSpPr/>
          <p:nvPr/>
        </p:nvSpPr>
        <p:spPr>
          <a:xfrm>
            <a:off x="2229840" y="-1440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"/>
          <p:cNvSpPr/>
          <p:nvPr/>
        </p:nvSpPr>
        <p:spPr>
          <a:xfrm>
            <a:off x="247680" y="6292800"/>
            <a:ext cx="626436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1</a:t>
            </a: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: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 Ubiquitination profile of E2F1 in HeLa cells co-transfected with pCMV-3HA-E2F1 wt or K185R (C) mutant, and His-tagged ubiquitin in the presence or absence of cIAP1 encoding vector. E2F1 was immunoprecipitated using anti-HA antibody and ubiquitin revealed using anti-poly-ubiquitin chain antibody (FK2). The expression of the transgenes was checked by a western blot analysis. β-actin was used as loading control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43"/>
          <p:cNvSpPr/>
          <p:nvPr/>
        </p:nvSpPr>
        <p:spPr>
          <a:xfrm>
            <a:off x="2372760" y="1459080"/>
            <a:ext cx="717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3HA-E2F1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cIAP1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44"/>
          <p:cNvSpPr/>
          <p:nvPr/>
        </p:nvSpPr>
        <p:spPr>
          <a:xfrm>
            <a:off x="2979720" y="1603440"/>
            <a:ext cx="113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+      -     +     </a:t>
            </a: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   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47"/>
          <p:cNvSpPr/>
          <p:nvPr/>
        </p:nvSpPr>
        <p:spPr>
          <a:xfrm>
            <a:off x="2257560" y="1855800"/>
            <a:ext cx="920520" cy="123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IB : Ub (FK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IB: 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IB: cIAP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onnecteur droit 48"/>
          <p:cNvSpPr/>
          <p:nvPr/>
        </p:nvSpPr>
        <p:spPr>
          <a:xfrm>
            <a:off x="3711600" y="1536840"/>
            <a:ext cx="0" cy="257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onnecteur droit 73"/>
          <p:cNvSpPr/>
          <p:nvPr/>
        </p:nvSpPr>
        <p:spPr>
          <a:xfrm>
            <a:off x="3413160" y="148428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74"/>
          <p:cNvSpPr/>
          <p:nvPr/>
        </p:nvSpPr>
        <p:spPr>
          <a:xfrm>
            <a:off x="2684520" y="1276200"/>
            <a:ext cx="137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IP:       IgG             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ZoneTexte 75"/>
          <p:cNvSpPr/>
          <p:nvPr/>
        </p:nvSpPr>
        <p:spPr>
          <a:xfrm>
            <a:off x="3238920" y="1479600"/>
            <a:ext cx="88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wt           K18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oupe 54"/>
          <p:cNvGrpSpPr/>
          <p:nvPr/>
        </p:nvGrpSpPr>
        <p:grpSpPr>
          <a:xfrm>
            <a:off x="4135680" y="1774800"/>
            <a:ext cx="336240" cy="215640"/>
            <a:chOff x="4135680" y="1774800"/>
            <a:chExt cx="336240" cy="215640"/>
          </a:xfrm>
        </p:grpSpPr>
        <p:sp>
          <p:nvSpPr>
            <p:cNvPr id="58" name="Connecteur droit 55"/>
            <p:cNvSpPr/>
            <p:nvPr/>
          </p:nvSpPr>
          <p:spPr>
            <a:xfrm>
              <a:off x="4160520" y="188712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ZoneTexte 56"/>
            <p:cNvSpPr/>
            <p:nvPr/>
          </p:nvSpPr>
          <p:spPr>
            <a:xfrm>
              <a:off x="4135680" y="177480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0" name="Groupe 57"/>
          <p:cNvGrpSpPr/>
          <p:nvPr/>
        </p:nvGrpSpPr>
        <p:grpSpPr>
          <a:xfrm>
            <a:off x="4135320" y="2367000"/>
            <a:ext cx="284400" cy="215640"/>
            <a:chOff x="4135320" y="2367000"/>
            <a:chExt cx="284400" cy="215640"/>
          </a:xfrm>
        </p:grpSpPr>
        <p:sp>
          <p:nvSpPr>
            <p:cNvPr id="61" name="Connecteur droit 58"/>
            <p:cNvSpPr/>
            <p:nvPr/>
          </p:nvSpPr>
          <p:spPr>
            <a:xfrm>
              <a:off x="4160520" y="248004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ZoneTexte 59"/>
            <p:cNvSpPr/>
            <p:nvPr/>
          </p:nvSpPr>
          <p:spPr>
            <a:xfrm>
              <a:off x="4135320" y="236700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" name="Groupe 60"/>
          <p:cNvGrpSpPr/>
          <p:nvPr/>
        </p:nvGrpSpPr>
        <p:grpSpPr>
          <a:xfrm>
            <a:off x="4133880" y="2593800"/>
            <a:ext cx="776520" cy="215640"/>
            <a:chOff x="4133880" y="2593800"/>
            <a:chExt cx="776520" cy="215640"/>
          </a:xfrm>
        </p:grpSpPr>
        <p:sp>
          <p:nvSpPr>
            <p:cNvPr id="64" name="Connecteur droit 61"/>
            <p:cNvSpPr/>
            <p:nvPr/>
          </p:nvSpPr>
          <p:spPr>
            <a:xfrm>
              <a:off x="4160160" y="270684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ZoneTexte 62"/>
            <p:cNvSpPr/>
            <p:nvPr/>
          </p:nvSpPr>
          <p:spPr>
            <a:xfrm>
              <a:off x="4133880" y="2593800"/>
              <a:ext cx="77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70 (3HA-E2F1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Groupe 63"/>
          <p:cNvGrpSpPr/>
          <p:nvPr/>
        </p:nvGrpSpPr>
        <p:grpSpPr>
          <a:xfrm>
            <a:off x="4135320" y="2797200"/>
            <a:ext cx="284400" cy="215640"/>
            <a:chOff x="4135320" y="2797200"/>
            <a:chExt cx="284400" cy="215640"/>
          </a:xfrm>
        </p:grpSpPr>
        <p:sp>
          <p:nvSpPr>
            <p:cNvPr id="67" name="Connecteur droit 64"/>
            <p:cNvSpPr/>
            <p:nvPr/>
          </p:nvSpPr>
          <p:spPr>
            <a:xfrm>
              <a:off x="4160520" y="291024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ZoneTexte 65"/>
            <p:cNvSpPr/>
            <p:nvPr/>
          </p:nvSpPr>
          <p:spPr>
            <a:xfrm>
              <a:off x="4135320" y="279720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9" name="ZoneTexte 60"/>
          <p:cNvSpPr/>
          <p:nvPr/>
        </p:nvSpPr>
        <p:spPr>
          <a:xfrm>
            <a:off x="2822400" y="3121200"/>
            <a:ext cx="5922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   </a:t>
            </a: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IAP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SC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0" name="Groupe 66"/>
          <p:cNvGrpSpPr/>
          <p:nvPr/>
        </p:nvGrpSpPr>
        <p:grpSpPr>
          <a:xfrm>
            <a:off x="4151160" y="3184560"/>
            <a:ext cx="284400" cy="215640"/>
            <a:chOff x="4151160" y="3184560"/>
            <a:chExt cx="284400" cy="215640"/>
          </a:xfrm>
        </p:grpSpPr>
        <p:sp>
          <p:nvSpPr>
            <p:cNvPr id="71" name="Connecteur droit 67"/>
            <p:cNvSpPr/>
            <p:nvPr/>
          </p:nvSpPr>
          <p:spPr>
            <a:xfrm>
              <a:off x="4176360" y="329760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ZoneTexte 68"/>
            <p:cNvSpPr/>
            <p:nvPr/>
          </p:nvSpPr>
          <p:spPr>
            <a:xfrm>
              <a:off x="4151160" y="318456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3" name="Groupe 69"/>
          <p:cNvGrpSpPr/>
          <p:nvPr/>
        </p:nvGrpSpPr>
        <p:grpSpPr>
          <a:xfrm>
            <a:off x="4151160" y="3449520"/>
            <a:ext cx="284400" cy="215640"/>
            <a:chOff x="4151160" y="3449520"/>
            <a:chExt cx="284400" cy="215640"/>
          </a:xfrm>
        </p:grpSpPr>
        <p:sp>
          <p:nvSpPr>
            <p:cNvPr id="74" name="Connecteur droit 70"/>
            <p:cNvSpPr/>
            <p:nvPr/>
          </p:nvSpPr>
          <p:spPr>
            <a:xfrm>
              <a:off x="4176360" y="356184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ZoneTexte 71"/>
            <p:cNvSpPr/>
            <p:nvPr/>
          </p:nvSpPr>
          <p:spPr>
            <a:xfrm>
              <a:off x="4151160" y="344952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" name="ZoneTexte 60"/>
          <p:cNvSpPr/>
          <p:nvPr/>
        </p:nvSpPr>
        <p:spPr>
          <a:xfrm>
            <a:off x="2489040" y="3119400"/>
            <a:ext cx="5907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nput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Connecteur droit 3"/>
          <p:cNvSpPr/>
          <p:nvPr/>
        </p:nvSpPr>
        <p:spPr>
          <a:xfrm>
            <a:off x="2965320" y="3200400"/>
            <a:ext cx="0" cy="442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Picture 2" descr=""/>
          <p:cNvPicPr/>
          <p:nvPr/>
        </p:nvPicPr>
        <p:blipFill>
          <a:blip r:embed="rId1"/>
          <a:stretch/>
        </p:blipFill>
        <p:spPr>
          <a:xfrm>
            <a:off x="3122640" y="1793880"/>
            <a:ext cx="1006560" cy="7192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79" name="Picture 3" descr=""/>
          <p:cNvPicPr/>
          <p:nvPr/>
        </p:nvPicPr>
        <p:blipFill>
          <a:blip r:embed="rId2"/>
          <a:stretch/>
        </p:blipFill>
        <p:spPr>
          <a:xfrm>
            <a:off x="3122640" y="2565360"/>
            <a:ext cx="1006560" cy="2318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80" name="Picture 4" descr=""/>
          <p:cNvPicPr/>
          <p:nvPr/>
        </p:nvPicPr>
        <p:blipFill>
          <a:blip r:embed="rId3"/>
          <a:stretch/>
        </p:blipFill>
        <p:spPr>
          <a:xfrm>
            <a:off x="3122640" y="2843280"/>
            <a:ext cx="1006560" cy="1951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81" name="Picture 5" descr=""/>
          <p:cNvPicPr/>
          <p:nvPr/>
        </p:nvPicPr>
        <p:blipFill>
          <a:blip r:embed="rId4"/>
          <a:stretch/>
        </p:blipFill>
        <p:spPr>
          <a:xfrm>
            <a:off x="3354480" y="3184560"/>
            <a:ext cx="774720" cy="2016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82" name="Picture 6" descr=""/>
          <p:cNvPicPr/>
          <p:nvPr/>
        </p:nvPicPr>
        <p:blipFill>
          <a:blip r:embed="rId5"/>
          <a:stretch/>
        </p:blipFill>
        <p:spPr>
          <a:xfrm>
            <a:off x="3354480" y="3438360"/>
            <a:ext cx="774720" cy="2127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ZoneTexte 5"/>
          <p:cNvSpPr/>
          <p:nvPr/>
        </p:nvSpPr>
        <p:spPr>
          <a:xfrm>
            <a:off x="2255400" y="2359080"/>
            <a:ext cx="513000" cy="29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  <a:ea typeface="Times New Roman"/>
              </a:rPr>
              <a:t>IB: H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ZoneTexte 6"/>
          <p:cNvSpPr/>
          <p:nvPr/>
        </p:nvSpPr>
        <p:spPr>
          <a:xfrm>
            <a:off x="2507040" y="1895400"/>
            <a:ext cx="1533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</a:rPr>
              <a:t>IP:               E2F1            Ig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ZoneTexte 7"/>
          <p:cNvSpPr/>
          <p:nvPr/>
        </p:nvSpPr>
        <p:spPr>
          <a:xfrm>
            <a:off x="2019240" y="2100240"/>
            <a:ext cx="211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</a:rPr>
              <a:t>3HA-E2F1 :    -  K/R  wt  wt    -     wt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6" name="Groupe 8"/>
          <p:cNvGrpSpPr/>
          <p:nvPr/>
        </p:nvGrpSpPr>
        <p:grpSpPr>
          <a:xfrm>
            <a:off x="3989880" y="2811600"/>
            <a:ext cx="674640" cy="200520"/>
            <a:chOff x="3989880" y="2811600"/>
            <a:chExt cx="674640" cy="200520"/>
          </a:xfrm>
        </p:grpSpPr>
        <p:sp>
          <p:nvSpPr>
            <p:cNvPr id="87" name="Connecteur droit 30"/>
            <p:cNvSpPr/>
            <p:nvPr/>
          </p:nvSpPr>
          <p:spPr>
            <a:xfrm>
              <a:off x="4003200" y="292428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ZoneTexte 31"/>
            <p:cNvSpPr/>
            <p:nvPr/>
          </p:nvSpPr>
          <p:spPr>
            <a:xfrm>
              <a:off x="3989880" y="2811600"/>
              <a:ext cx="67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Helvetica LT Std"/>
                </a:rPr>
                <a:t>53 (HA-DP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9" name="Groupe 9"/>
          <p:cNvGrpSpPr/>
          <p:nvPr/>
        </p:nvGrpSpPr>
        <p:grpSpPr>
          <a:xfrm>
            <a:off x="3993480" y="2443320"/>
            <a:ext cx="752400" cy="200520"/>
            <a:chOff x="3993480" y="2443320"/>
            <a:chExt cx="752400" cy="200520"/>
          </a:xfrm>
        </p:grpSpPr>
        <p:sp>
          <p:nvSpPr>
            <p:cNvPr id="90" name="Connecteur droit 28"/>
            <p:cNvSpPr/>
            <p:nvPr/>
          </p:nvSpPr>
          <p:spPr>
            <a:xfrm>
              <a:off x="4000320" y="255600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ZoneTexte 29"/>
            <p:cNvSpPr/>
            <p:nvPr/>
          </p:nvSpPr>
          <p:spPr>
            <a:xfrm>
              <a:off x="3993480" y="2443320"/>
              <a:ext cx="75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Helvetica LT Std"/>
                </a:rPr>
                <a:t>70 (3HA-E2F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2" name="Connecteur droit 10"/>
          <p:cNvSpPr/>
          <p:nvPr/>
        </p:nvSpPr>
        <p:spPr>
          <a:xfrm>
            <a:off x="2797200" y="2109960"/>
            <a:ext cx="906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Connecteur droit 11"/>
          <p:cNvSpPr/>
          <p:nvPr/>
        </p:nvSpPr>
        <p:spPr>
          <a:xfrm>
            <a:off x="3809880" y="2109960"/>
            <a:ext cx="146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ZoneTexte 12"/>
          <p:cNvSpPr/>
          <p:nvPr/>
        </p:nvSpPr>
        <p:spPr>
          <a:xfrm>
            <a:off x="2278080" y="3160800"/>
            <a:ext cx="513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  <a:ea typeface="Times New Roman"/>
              </a:rPr>
              <a:t>IB: H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  <a:ea typeface="Times New Roman"/>
              </a:rPr>
              <a:t>E2F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5" name="Groupe 13"/>
          <p:cNvGrpSpPr/>
          <p:nvPr/>
        </p:nvGrpSpPr>
        <p:grpSpPr>
          <a:xfrm>
            <a:off x="3991680" y="3257640"/>
            <a:ext cx="752400" cy="200520"/>
            <a:chOff x="3991680" y="3257640"/>
            <a:chExt cx="752400" cy="200520"/>
          </a:xfrm>
        </p:grpSpPr>
        <p:sp>
          <p:nvSpPr>
            <p:cNvPr id="96" name="Connecteur droit 26"/>
            <p:cNvSpPr/>
            <p:nvPr/>
          </p:nvSpPr>
          <p:spPr>
            <a:xfrm>
              <a:off x="3998520" y="337032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ZoneTexte 27"/>
            <p:cNvSpPr/>
            <p:nvPr/>
          </p:nvSpPr>
          <p:spPr>
            <a:xfrm>
              <a:off x="3991680" y="3257640"/>
              <a:ext cx="75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Helvetica LT Std"/>
                </a:rPr>
                <a:t>70 (3HA-E2F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8" name="Groupe 14"/>
          <p:cNvGrpSpPr/>
          <p:nvPr/>
        </p:nvGrpSpPr>
        <p:grpSpPr>
          <a:xfrm>
            <a:off x="3983760" y="3586320"/>
            <a:ext cx="674640" cy="200520"/>
            <a:chOff x="3983760" y="3586320"/>
            <a:chExt cx="674640" cy="200520"/>
          </a:xfrm>
        </p:grpSpPr>
        <p:sp>
          <p:nvSpPr>
            <p:cNvPr id="99" name="Connecteur droit 24"/>
            <p:cNvSpPr/>
            <p:nvPr/>
          </p:nvSpPr>
          <p:spPr>
            <a:xfrm>
              <a:off x="3997080" y="369900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ZoneTexte 25"/>
            <p:cNvSpPr/>
            <p:nvPr/>
          </p:nvSpPr>
          <p:spPr>
            <a:xfrm>
              <a:off x="3983760" y="3586320"/>
              <a:ext cx="67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Helvetica LT Std"/>
                </a:rPr>
                <a:t>53 (HA-DP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1" name="Groupe 15"/>
          <p:cNvGrpSpPr/>
          <p:nvPr/>
        </p:nvGrpSpPr>
        <p:grpSpPr>
          <a:xfrm>
            <a:off x="3978000" y="3824280"/>
            <a:ext cx="752400" cy="200520"/>
            <a:chOff x="3978000" y="3824280"/>
            <a:chExt cx="752400" cy="200520"/>
          </a:xfrm>
        </p:grpSpPr>
        <p:sp>
          <p:nvSpPr>
            <p:cNvPr id="102" name="Connecteur droit 22"/>
            <p:cNvSpPr/>
            <p:nvPr/>
          </p:nvSpPr>
          <p:spPr>
            <a:xfrm>
              <a:off x="3984120" y="393732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ZoneTexte 23"/>
            <p:cNvSpPr/>
            <p:nvPr/>
          </p:nvSpPr>
          <p:spPr>
            <a:xfrm>
              <a:off x="3978000" y="3824280"/>
              <a:ext cx="75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Helvetica LT Std"/>
                </a:rPr>
                <a:t>70 (3HA-E2F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4" name="ZoneTexte 16"/>
          <p:cNvSpPr/>
          <p:nvPr/>
        </p:nvSpPr>
        <p:spPr>
          <a:xfrm>
            <a:off x="2135160" y="2241720"/>
            <a:ext cx="2436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</a:rPr>
              <a:t>HA-DP1 :    -    +     +    -     +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Connecteur droit 17"/>
          <p:cNvSpPr/>
          <p:nvPr/>
        </p:nvSpPr>
        <p:spPr>
          <a:xfrm>
            <a:off x="2352600" y="3201840"/>
            <a:ext cx="0" cy="86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ZoneTexte 18"/>
          <p:cNvSpPr/>
          <p:nvPr/>
        </p:nvSpPr>
        <p:spPr>
          <a:xfrm>
            <a:off x="1956240" y="315432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Helvetica LT Std"/>
              </a:rPr>
              <a:t>Input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Picture 3" descr=""/>
          <p:cNvPicPr/>
          <p:nvPr/>
        </p:nvPicPr>
        <p:blipFill>
          <a:blip r:embed="rId1"/>
          <a:stretch/>
        </p:blipFill>
        <p:spPr>
          <a:xfrm>
            <a:off x="2730600" y="2438280"/>
            <a:ext cx="1252440" cy="6177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8" name="Picture 2" descr=""/>
          <p:cNvPicPr/>
          <p:nvPr/>
        </p:nvPicPr>
        <p:blipFill>
          <a:blip r:embed="rId2"/>
          <a:stretch/>
        </p:blipFill>
        <p:spPr>
          <a:xfrm>
            <a:off x="2735280" y="3214800"/>
            <a:ext cx="1243080" cy="6238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9" name="Picture 4" descr=""/>
          <p:cNvPicPr/>
          <p:nvPr/>
        </p:nvPicPr>
        <p:blipFill>
          <a:blip r:embed="rId3"/>
          <a:stretch/>
        </p:blipFill>
        <p:spPr>
          <a:xfrm>
            <a:off x="2735280" y="3895560"/>
            <a:ext cx="1243080" cy="1587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110" name="ZoneTexte 32"/>
          <p:cNvSpPr/>
          <p:nvPr/>
        </p:nvSpPr>
        <p:spPr>
          <a:xfrm>
            <a:off x="2229840" y="-1440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1"/>
          <p:cNvSpPr/>
          <p:nvPr/>
        </p:nvSpPr>
        <p:spPr>
          <a:xfrm>
            <a:off x="189000" y="4716360"/>
            <a:ext cx="611964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2</a:t>
            </a: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: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 Immunoprecipitation analysis of the interaction of DP1 with E2F1 wt or K161/164R mutant (K/R). Hela cells were transfected with 3HA-E2F1 encoding constructs and HA-DP1 encoding vector. E2F1 were immunoprecipitated using an anti-E2F1 antibody and DP1-E2F1 interaction was revealed by a western blot analysis by using anti-HA antibody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ZoneTexte 65"/>
          <p:cNvSpPr/>
          <p:nvPr/>
        </p:nvSpPr>
        <p:spPr>
          <a:xfrm>
            <a:off x="545040" y="148608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ZoneTexte 50"/>
          <p:cNvSpPr/>
          <p:nvPr/>
        </p:nvSpPr>
        <p:spPr>
          <a:xfrm>
            <a:off x="2134800" y="-15840"/>
            <a:ext cx="249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Supplementary Figure 3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ZoneTexte 3"/>
          <p:cNvSpPr/>
          <p:nvPr/>
        </p:nvSpPr>
        <p:spPr>
          <a:xfrm rot="16200000">
            <a:off x="689040" y="3068280"/>
            <a:ext cx="79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Cell count (AU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5" name="Groupe 15"/>
          <p:cNvGrpSpPr/>
          <p:nvPr/>
        </p:nvGrpSpPr>
        <p:grpSpPr>
          <a:xfrm>
            <a:off x="373680" y="1703520"/>
            <a:ext cx="3493440" cy="2270520"/>
            <a:chOff x="373680" y="1703520"/>
            <a:chExt cx="3493440" cy="2270520"/>
          </a:xfrm>
        </p:grpSpPr>
        <p:grpSp>
          <p:nvGrpSpPr>
            <p:cNvPr id="116" name="Groupe 55"/>
            <p:cNvGrpSpPr/>
            <p:nvPr/>
          </p:nvGrpSpPr>
          <p:grpSpPr>
            <a:xfrm>
              <a:off x="373680" y="1703520"/>
              <a:ext cx="3493440" cy="2060280"/>
              <a:chOff x="373680" y="1703520"/>
              <a:chExt cx="3493440" cy="2060280"/>
            </a:xfrm>
          </p:grpSpPr>
          <p:pic>
            <p:nvPicPr>
              <p:cNvPr id="117" name="Picture 2" descr=""/>
              <p:cNvPicPr/>
              <p:nvPr/>
            </p:nvPicPr>
            <p:blipFill>
              <a:blip r:embed="rId1"/>
              <a:srcRect l="0" t="7338" r="20922" b="0"/>
              <a:stretch/>
            </p:blipFill>
            <p:spPr>
              <a:xfrm>
                <a:off x="1140840" y="2643480"/>
                <a:ext cx="904680" cy="111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8" name="ZoneTexte 58"/>
              <p:cNvSpPr/>
              <p:nvPr/>
            </p:nvSpPr>
            <p:spPr>
              <a:xfrm>
                <a:off x="373680" y="1856880"/>
                <a:ext cx="968760" cy="703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G1 (%):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S (%):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G2 (%):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S median (AU):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19" name="Picture 3" descr=""/>
              <p:cNvPicPr/>
              <p:nvPr/>
            </p:nvPicPr>
            <p:blipFill>
              <a:blip r:embed="rId2"/>
              <a:srcRect l="0" t="7330" r="18831" b="0"/>
              <a:stretch/>
            </p:blipFill>
            <p:spPr>
              <a:xfrm>
                <a:off x="1945080" y="2643480"/>
                <a:ext cx="928440" cy="111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0" name="ZoneTexte 60"/>
              <p:cNvSpPr/>
              <p:nvPr/>
            </p:nvSpPr>
            <p:spPr>
              <a:xfrm>
                <a:off x="2014560" y="1712520"/>
                <a:ext cx="714240" cy="855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si-Cyclin 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11.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61.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23.9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104 649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21" name="Picture 5" descr=""/>
              <p:cNvPicPr/>
              <p:nvPr/>
            </p:nvPicPr>
            <p:blipFill>
              <a:blip r:embed="rId3"/>
              <a:srcRect l="0" t="8581" r="22810" b="0"/>
              <a:stretch/>
            </p:blipFill>
            <p:spPr>
              <a:xfrm>
                <a:off x="2984040" y="2664000"/>
                <a:ext cx="883080" cy="1099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2" name="ZoneTexte 62"/>
              <p:cNvSpPr/>
              <p:nvPr/>
            </p:nvSpPr>
            <p:spPr>
              <a:xfrm>
                <a:off x="3081600" y="1703520"/>
                <a:ext cx="529560" cy="855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Si-Rb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32.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38.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38.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97 32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ZoneTexte 63"/>
              <p:cNvSpPr/>
              <p:nvPr/>
            </p:nvSpPr>
            <p:spPr>
              <a:xfrm>
                <a:off x="1269720" y="1703520"/>
                <a:ext cx="529560" cy="855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si-C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20.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59.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20.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85 81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4" name="ZoneTexte 14"/>
            <p:cNvSpPr/>
            <p:nvPr/>
          </p:nvSpPr>
          <p:spPr>
            <a:xfrm>
              <a:off x="2101680" y="3758400"/>
              <a:ext cx="71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DNA conten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5" name="Rectangle 1"/>
          <p:cNvSpPr/>
          <p:nvPr/>
        </p:nvSpPr>
        <p:spPr>
          <a:xfrm>
            <a:off x="149400" y="6804000"/>
            <a:ext cx="6553080" cy="14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Supplementary Figure 3: A. 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Cell cycle analysis of U2OS cells 48 hours after transfection with co, cyclin A or Rb siRNA. The percentage of cells in cell cycle phase and the median of cell in S phase are indicated (upper) </a:t>
            </a: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B-C. Influence of Rb on E2F1 ubiquitination. 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HeLa cells were co-transfected with Rb-encoding vector (B) or U2OS cells with cyclin A or Rb siRNA (C), and with pCMV-3HA-E2F1 and His-tagged ubiquitin wt. E2F1 was immunoprecipitated using anti-E2F1 antibody and ubiquitin revealed using anti-poly-ubiquitin chain antibody (FK2). The expression of the transgenes and the efficiency of siRNA were checked by a western blot analysis (lower panels). β-actin or α-tubulin was used as loading control.</a:t>
            </a: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 D.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 GST-pull down analysis of the interaction of GST-E2F1 with Rb in the presence of increasing quantity of cIAP1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6" name="Groupe 16"/>
          <p:cNvGrpSpPr/>
          <p:nvPr/>
        </p:nvGrpSpPr>
        <p:grpSpPr>
          <a:xfrm>
            <a:off x="4341960" y="1501920"/>
            <a:ext cx="2348280" cy="2481120"/>
            <a:chOff x="4341960" y="1501920"/>
            <a:chExt cx="2348280" cy="2481120"/>
          </a:xfrm>
        </p:grpSpPr>
        <p:sp>
          <p:nvSpPr>
            <p:cNvPr id="127" name="ZoneTexte 2"/>
            <p:cNvSpPr/>
            <p:nvPr/>
          </p:nvSpPr>
          <p:spPr>
            <a:xfrm>
              <a:off x="5002560" y="1792800"/>
              <a:ext cx="125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P:  IgG     E2F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ZoneTexte 4"/>
            <p:cNvSpPr/>
            <p:nvPr/>
          </p:nvSpPr>
          <p:spPr>
            <a:xfrm>
              <a:off x="4506840" y="2134440"/>
              <a:ext cx="813240" cy="10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B : Ub (FK2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B: E2F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ZoneTexte 5"/>
            <p:cNvSpPr/>
            <p:nvPr/>
          </p:nvSpPr>
          <p:spPr>
            <a:xfrm>
              <a:off x="5270040" y="1973880"/>
              <a:ext cx="615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V     V  R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Connecteur droit 6"/>
            <p:cNvSpPr/>
            <p:nvPr/>
          </p:nvSpPr>
          <p:spPr>
            <a:xfrm>
              <a:off x="5533920" y="1994400"/>
              <a:ext cx="32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Connecteur droit 7"/>
            <p:cNvSpPr/>
            <p:nvPr/>
          </p:nvSpPr>
          <p:spPr>
            <a:xfrm>
              <a:off x="4879080" y="3359880"/>
              <a:ext cx="0" cy="32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ZoneTexte 60"/>
            <p:cNvSpPr/>
            <p:nvPr/>
          </p:nvSpPr>
          <p:spPr>
            <a:xfrm>
              <a:off x="4341960" y="3234960"/>
              <a:ext cx="1148760" cy="74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nput               Rb    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α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-tubul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ZoneTexte 13"/>
            <p:cNvSpPr/>
            <p:nvPr/>
          </p:nvSpPr>
          <p:spPr>
            <a:xfrm>
              <a:off x="4591080" y="1501920"/>
              <a:ext cx="756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B. </a:t>
              </a: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HeLa</a:t>
              </a: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4" name="Groupe 52"/>
            <p:cNvGrpSpPr/>
            <p:nvPr/>
          </p:nvGrpSpPr>
          <p:grpSpPr>
            <a:xfrm>
              <a:off x="5906160" y="2118960"/>
              <a:ext cx="336240" cy="215640"/>
              <a:chOff x="5906160" y="2118960"/>
              <a:chExt cx="336240" cy="215640"/>
            </a:xfrm>
          </p:grpSpPr>
          <p:sp>
            <p:nvSpPr>
              <p:cNvPr id="135" name="Connecteur droit 53"/>
              <p:cNvSpPr/>
              <p:nvPr/>
            </p:nvSpPr>
            <p:spPr>
              <a:xfrm>
                <a:off x="5931360" y="223164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ZoneTexte 56"/>
              <p:cNvSpPr/>
              <p:nvPr/>
            </p:nvSpPr>
            <p:spPr>
              <a:xfrm>
                <a:off x="5906160" y="2118960"/>
                <a:ext cx="33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1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7" name="Groupe 64"/>
            <p:cNvGrpSpPr/>
            <p:nvPr/>
          </p:nvGrpSpPr>
          <p:grpSpPr>
            <a:xfrm>
              <a:off x="5906160" y="2818080"/>
              <a:ext cx="284400" cy="215640"/>
              <a:chOff x="5906160" y="2818080"/>
              <a:chExt cx="284400" cy="215640"/>
            </a:xfrm>
          </p:grpSpPr>
          <p:sp>
            <p:nvSpPr>
              <p:cNvPr id="138" name="Connecteur droit 66"/>
              <p:cNvSpPr/>
              <p:nvPr/>
            </p:nvSpPr>
            <p:spPr>
              <a:xfrm>
                <a:off x="5931360" y="29307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ZoneTexte 67"/>
              <p:cNvSpPr/>
              <p:nvPr/>
            </p:nvSpPr>
            <p:spPr>
              <a:xfrm>
                <a:off x="5906160" y="281808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0" name="Groupe 68"/>
            <p:cNvGrpSpPr/>
            <p:nvPr/>
          </p:nvGrpSpPr>
          <p:grpSpPr>
            <a:xfrm>
              <a:off x="5913720" y="2975760"/>
              <a:ext cx="776520" cy="215640"/>
              <a:chOff x="5913720" y="2975760"/>
              <a:chExt cx="776520" cy="215640"/>
            </a:xfrm>
          </p:grpSpPr>
          <p:sp>
            <p:nvSpPr>
              <p:cNvPr id="141" name="Connecteur droit 69"/>
              <p:cNvSpPr/>
              <p:nvPr/>
            </p:nvSpPr>
            <p:spPr>
              <a:xfrm>
                <a:off x="5940000" y="308844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ZoneTexte 70"/>
              <p:cNvSpPr/>
              <p:nvPr/>
            </p:nvSpPr>
            <p:spPr>
              <a:xfrm>
                <a:off x="5913720" y="2975760"/>
                <a:ext cx="776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70 (3HA-E2F1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3" name="Groupe 71"/>
            <p:cNvGrpSpPr/>
            <p:nvPr/>
          </p:nvGrpSpPr>
          <p:grpSpPr>
            <a:xfrm>
              <a:off x="5914800" y="3306240"/>
              <a:ext cx="336240" cy="215640"/>
              <a:chOff x="5914800" y="3306240"/>
              <a:chExt cx="336240" cy="215640"/>
            </a:xfrm>
          </p:grpSpPr>
          <p:sp>
            <p:nvSpPr>
              <p:cNvPr id="144" name="Connecteur droit 72"/>
              <p:cNvSpPr/>
              <p:nvPr/>
            </p:nvSpPr>
            <p:spPr>
              <a:xfrm>
                <a:off x="5940000" y="341892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ZoneTexte 73"/>
              <p:cNvSpPr/>
              <p:nvPr/>
            </p:nvSpPr>
            <p:spPr>
              <a:xfrm>
                <a:off x="5914800" y="3306240"/>
                <a:ext cx="33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1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6" name="Groupe 74"/>
            <p:cNvGrpSpPr/>
            <p:nvPr/>
          </p:nvGrpSpPr>
          <p:grpSpPr>
            <a:xfrm>
              <a:off x="5914800" y="3491280"/>
              <a:ext cx="284400" cy="215640"/>
              <a:chOff x="5914800" y="3491280"/>
              <a:chExt cx="284400" cy="215640"/>
            </a:xfrm>
          </p:grpSpPr>
          <p:sp>
            <p:nvSpPr>
              <p:cNvPr id="147" name="Connecteur droit 75"/>
              <p:cNvSpPr/>
              <p:nvPr/>
            </p:nvSpPr>
            <p:spPr>
              <a:xfrm>
                <a:off x="5940000" y="36039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ZoneTexte 76"/>
              <p:cNvSpPr/>
              <p:nvPr/>
            </p:nvSpPr>
            <p:spPr>
              <a:xfrm>
                <a:off x="5914800" y="349128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5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49" name="Picture 2" descr=""/>
            <p:cNvPicPr/>
            <p:nvPr/>
          </p:nvPicPr>
          <p:blipFill>
            <a:blip r:embed="rId4"/>
            <a:stretch/>
          </p:blipFill>
          <p:spPr>
            <a:xfrm>
              <a:off x="5305680" y="2181240"/>
              <a:ext cx="615960" cy="7804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50" name="Picture 3" descr=""/>
            <p:cNvPicPr/>
            <p:nvPr/>
          </p:nvPicPr>
          <p:blipFill>
            <a:blip r:embed="rId5"/>
            <a:stretch/>
          </p:blipFill>
          <p:spPr>
            <a:xfrm>
              <a:off x="5305680" y="2997000"/>
              <a:ext cx="615960" cy="2188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51" name="Picture 4" descr=""/>
            <p:cNvPicPr/>
            <p:nvPr/>
          </p:nvPicPr>
          <p:blipFill>
            <a:blip r:embed="rId6"/>
            <a:stretch/>
          </p:blipFill>
          <p:spPr>
            <a:xfrm>
              <a:off x="5451480" y="3300840"/>
              <a:ext cx="469800" cy="1821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52" name="Picture 5" descr=""/>
            <p:cNvPicPr/>
            <p:nvPr/>
          </p:nvPicPr>
          <p:blipFill>
            <a:blip r:embed="rId7"/>
            <a:stretch/>
          </p:blipFill>
          <p:spPr>
            <a:xfrm>
              <a:off x="5451480" y="3511800"/>
              <a:ext cx="469800" cy="1713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</p:grpSp>
      <p:grpSp>
        <p:nvGrpSpPr>
          <p:cNvPr id="153" name="Groupe 17"/>
          <p:cNvGrpSpPr/>
          <p:nvPr/>
        </p:nvGrpSpPr>
        <p:grpSpPr>
          <a:xfrm>
            <a:off x="520560" y="3909960"/>
            <a:ext cx="2424600" cy="2467440"/>
            <a:chOff x="520560" y="3909960"/>
            <a:chExt cx="2424600" cy="2467440"/>
          </a:xfrm>
        </p:grpSpPr>
        <p:sp>
          <p:nvSpPr>
            <p:cNvPr id="154" name="ZoneTexte 44"/>
            <p:cNvSpPr/>
            <p:nvPr/>
          </p:nvSpPr>
          <p:spPr>
            <a:xfrm>
              <a:off x="540000" y="3909960"/>
              <a:ext cx="784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C. </a:t>
              </a: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U2OS</a:t>
              </a: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ZoneTexte 45"/>
            <p:cNvSpPr/>
            <p:nvPr/>
          </p:nvSpPr>
          <p:spPr>
            <a:xfrm>
              <a:off x="587160" y="4488840"/>
              <a:ext cx="813240" cy="10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B : Ub (FK2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B: E2F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Connecteur droit 46"/>
            <p:cNvSpPr/>
            <p:nvPr/>
          </p:nvSpPr>
          <p:spPr>
            <a:xfrm>
              <a:off x="1619280" y="4402440"/>
              <a:ext cx="32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ZoneTexte 47"/>
            <p:cNvSpPr/>
            <p:nvPr/>
          </p:nvSpPr>
          <p:spPr>
            <a:xfrm>
              <a:off x="887400" y="4343040"/>
              <a:ext cx="1386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   </a:t>
              </a: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si-RNA:   Co  Co cyA Rb 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Connecteur droit 48"/>
            <p:cNvSpPr/>
            <p:nvPr/>
          </p:nvSpPr>
          <p:spPr>
            <a:xfrm>
              <a:off x="1021320" y="5736960"/>
              <a:ext cx="0" cy="61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ZoneTexte 60"/>
            <p:cNvSpPr/>
            <p:nvPr/>
          </p:nvSpPr>
          <p:spPr>
            <a:xfrm>
              <a:off x="520560" y="5629320"/>
              <a:ext cx="1148760" cy="74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nput                R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yclin 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α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-tubul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ZoneTexte 49"/>
            <p:cNvSpPr/>
            <p:nvPr/>
          </p:nvSpPr>
          <p:spPr>
            <a:xfrm>
              <a:off x="1146600" y="4200840"/>
              <a:ext cx="103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IP:  IgG    E2F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61" name="Groupe 77"/>
            <p:cNvGrpSpPr/>
            <p:nvPr/>
          </p:nvGrpSpPr>
          <p:grpSpPr>
            <a:xfrm>
              <a:off x="2147760" y="6141600"/>
              <a:ext cx="284400" cy="215640"/>
              <a:chOff x="2147760" y="6141600"/>
              <a:chExt cx="284400" cy="215640"/>
            </a:xfrm>
          </p:grpSpPr>
          <p:sp>
            <p:nvSpPr>
              <p:cNvPr id="162" name="Connecteur droit 78"/>
              <p:cNvSpPr/>
              <p:nvPr/>
            </p:nvSpPr>
            <p:spPr>
              <a:xfrm>
                <a:off x="2172960" y="625428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ZoneTexte 79"/>
              <p:cNvSpPr/>
              <p:nvPr/>
            </p:nvSpPr>
            <p:spPr>
              <a:xfrm>
                <a:off x="2147760" y="614160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5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4" name="Groupe 80"/>
            <p:cNvGrpSpPr/>
            <p:nvPr/>
          </p:nvGrpSpPr>
          <p:grpSpPr>
            <a:xfrm>
              <a:off x="2147400" y="5690520"/>
              <a:ext cx="336240" cy="215640"/>
              <a:chOff x="2147400" y="5690520"/>
              <a:chExt cx="336240" cy="215640"/>
            </a:xfrm>
          </p:grpSpPr>
          <p:sp>
            <p:nvSpPr>
              <p:cNvPr id="165" name="Connecteur droit 81"/>
              <p:cNvSpPr/>
              <p:nvPr/>
            </p:nvSpPr>
            <p:spPr>
              <a:xfrm>
                <a:off x="2172600" y="580320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ZoneTexte 82"/>
              <p:cNvSpPr/>
              <p:nvPr/>
            </p:nvSpPr>
            <p:spPr>
              <a:xfrm>
                <a:off x="2147400" y="5690520"/>
                <a:ext cx="33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1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7" name="Groupe 86"/>
            <p:cNvGrpSpPr/>
            <p:nvPr/>
          </p:nvGrpSpPr>
          <p:grpSpPr>
            <a:xfrm>
              <a:off x="2161080" y="4472280"/>
              <a:ext cx="336240" cy="215640"/>
              <a:chOff x="2161080" y="4472280"/>
              <a:chExt cx="336240" cy="215640"/>
            </a:xfrm>
          </p:grpSpPr>
          <p:sp>
            <p:nvSpPr>
              <p:cNvPr id="168" name="Connecteur droit 87"/>
              <p:cNvSpPr/>
              <p:nvPr/>
            </p:nvSpPr>
            <p:spPr>
              <a:xfrm>
                <a:off x="2186280" y="45849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ZoneTexte 88"/>
              <p:cNvSpPr/>
              <p:nvPr/>
            </p:nvSpPr>
            <p:spPr>
              <a:xfrm>
                <a:off x="2161080" y="4472280"/>
                <a:ext cx="33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1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0" name="Groupe 89"/>
            <p:cNvGrpSpPr/>
            <p:nvPr/>
          </p:nvGrpSpPr>
          <p:grpSpPr>
            <a:xfrm>
              <a:off x="2161440" y="5171760"/>
              <a:ext cx="284400" cy="215640"/>
              <a:chOff x="2161440" y="5171760"/>
              <a:chExt cx="284400" cy="215640"/>
            </a:xfrm>
          </p:grpSpPr>
          <p:sp>
            <p:nvSpPr>
              <p:cNvPr id="171" name="Connecteur droit 90"/>
              <p:cNvSpPr/>
              <p:nvPr/>
            </p:nvSpPr>
            <p:spPr>
              <a:xfrm>
                <a:off x="2186640" y="528444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ZoneTexte 91"/>
              <p:cNvSpPr/>
              <p:nvPr/>
            </p:nvSpPr>
            <p:spPr>
              <a:xfrm>
                <a:off x="2161440" y="517176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3" name="Groupe 92"/>
            <p:cNvGrpSpPr/>
            <p:nvPr/>
          </p:nvGrpSpPr>
          <p:grpSpPr>
            <a:xfrm>
              <a:off x="2168640" y="5329080"/>
              <a:ext cx="776520" cy="215640"/>
              <a:chOff x="2168640" y="5329080"/>
              <a:chExt cx="776520" cy="215640"/>
            </a:xfrm>
          </p:grpSpPr>
          <p:sp>
            <p:nvSpPr>
              <p:cNvPr id="174" name="Connecteur droit 93"/>
              <p:cNvSpPr/>
              <p:nvPr/>
            </p:nvSpPr>
            <p:spPr>
              <a:xfrm>
                <a:off x="2194920" y="54417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ZoneTexte 94"/>
              <p:cNvSpPr/>
              <p:nvPr/>
            </p:nvSpPr>
            <p:spPr>
              <a:xfrm>
                <a:off x="2168640" y="5329080"/>
                <a:ext cx="776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70 (3HA-E2F1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6" name="Groupe 84"/>
            <p:cNvGrpSpPr/>
            <p:nvPr/>
          </p:nvGrpSpPr>
          <p:grpSpPr>
            <a:xfrm>
              <a:off x="2138040" y="5910480"/>
              <a:ext cx="284400" cy="215640"/>
              <a:chOff x="2138040" y="5910480"/>
              <a:chExt cx="284400" cy="215640"/>
            </a:xfrm>
          </p:grpSpPr>
          <p:sp>
            <p:nvSpPr>
              <p:cNvPr id="177" name="Connecteur droit 85"/>
              <p:cNvSpPr/>
              <p:nvPr/>
            </p:nvSpPr>
            <p:spPr>
              <a:xfrm>
                <a:off x="2173680" y="6023160"/>
                <a:ext cx="32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ZoneTexte 95"/>
              <p:cNvSpPr/>
              <p:nvPr/>
            </p:nvSpPr>
            <p:spPr>
              <a:xfrm>
                <a:off x="2138040" y="591048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Calibri"/>
                  </a:rPr>
                  <a:t>5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79" name="Picture 6" descr=""/>
            <p:cNvPicPr/>
            <p:nvPr/>
          </p:nvPicPr>
          <p:blipFill>
            <a:blip r:embed="rId8"/>
            <a:stretch/>
          </p:blipFill>
          <p:spPr>
            <a:xfrm>
              <a:off x="1420560" y="4544280"/>
              <a:ext cx="755640" cy="7552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80" name="Picture 7" descr=""/>
            <p:cNvPicPr/>
            <p:nvPr/>
          </p:nvPicPr>
          <p:blipFill>
            <a:blip r:embed="rId9"/>
            <a:stretch/>
          </p:blipFill>
          <p:spPr>
            <a:xfrm>
              <a:off x="1420560" y="5329080"/>
              <a:ext cx="755640" cy="2444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81" name="Picture 8" descr=""/>
            <p:cNvPicPr/>
            <p:nvPr/>
          </p:nvPicPr>
          <p:blipFill>
            <a:blip r:embed="rId10"/>
            <a:stretch/>
          </p:blipFill>
          <p:spPr>
            <a:xfrm>
              <a:off x="1622160" y="5702760"/>
              <a:ext cx="554040" cy="2124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82" name="Picture 9" descr=""/>
            <p:cNvPicPr/>
            <p:nvPr/>
          </p:nvPicPr>
          <p:blipFill>
            <a:blip r:embed="rId11"/>
            <a:stretch/>
          </p:blipFill>
          <p:spPr>
            <a:xfrm>
              <a:off x="1622160" y="5947200"/>
              <a:ext cx="554040" cy="1522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183" name="Picture 10" descr=""/>
            <p:cNvPicPr/>
            <p:nvPr/>
          </p:nvPicPr>
          <p:blipFill>
            <a:blip r:embed="rId12"/>
            <a:stretch/>
          </p:blipFill>
          <p:spPr>
            <a:xfrm>
              <a:off x="1626840" y="6140880"/>
              <a:ext cx="549000" cy="20772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</p:grpSp>
      <p:grpSp>
        <p:nvGrpSpPr>
          <p:cNvPr id="184" name="Groupe 96"/>
          <p:cNvGrpSpPr/>
          <p:nvPr/>
        </p:nvGrpSpPr>
        <p:grpSpPr>
          <a:xfrm>
            <a:off x="3195360" y="4286160"/>
            <a:ext cx="2736000" cy="2029320"/>
            <a:chOff x="3195360" y="4286160"/>
            <a:chExt cx="2736000" cy="2029320"/>
          </a:xfrm>
        </p:grpSpPr>
        <p:sp>
          <p:nvSpPr>
            <p:cNvPr id="185" name="ZoneTexte 97"/>
            <p:cNvSpPr/>
            <p:nvPr/>
          </p:nvSpPr>
          <p:spPr>
            <a:xfrm>
              <a:off x="3861360" y="5592960"/>
              <a:ext cx="39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GS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ZoneTexte 98"/>
            <p:cNvSpPr/>
            <p:nvPr/>
          </p:nvSpPr>
          <p:spPr>
            <a:xfrm>
              <a:off x="3440880" y="5407200"/>
              <a:ext cx="826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GST E2F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ZoneTexte 99"/>
            <p:cNvSpPr/>
            <p:nvPr/>
          </p:nvSpPr>
          <p:spPr>
            <a:xfrm>
              <a:off x="3978360" y="4633920"/>
              <a:ext cx="32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R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ZoneTexte 100"/>
            <p:cNvSpPr/>
            <p:nvPr/>
          </p:nvSpPr>
          <p:spPr>
            <a:xfrm>
              <a:off x="3818880" y="478224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cIA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ZoneTexte 101"/>
            <p:cNvSpPr/>
            <p:nvPr/>
          </p:nvSpPr>
          <p:spPr>
            <a:xfrm>
              <a:off x="3940200" y="4935240"/>
              <a:ext cx="32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R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ZoneTexte 102"/>
            <p:cNvSpPr/>
            <p:nvPr/>
          </p:nvSpPr>
          <p:spPr>
            <a:xfrm>
              <a:off x="3780720" y="517104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cIA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ZoneTexte 103"/>
            <p:cNvSpPr/>
            <p:nvPr/>
          </p:nvSpPr>
          <p:spPr>
            <a:xfrm>
              <a:off x="3871440" y="5857560"/>
              <a:ext cx="32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R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ZoneTexte 104"/>
            <p:cNvSpPr/>
            <p:nvPr/>
          </p:nvSpPr>
          <p:spPr>
            <a:xfrm>
              <a:off x="3695760" y="608436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cIA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ZoneTexte 105"/>
            <p:cNvSpPr/>
            <p:nvPr/>
          </p:nvSpPr>
          <p:spPr>
            <a:xfrm flipV="1" rot="5400000">
              <a:off x="3170880" y="5963400"/>
              <a:ext cx="470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Inpu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ZoneTexte 106"/>
            <p:cNvSpPr/>
            <p:nvPr/>
          </p:nvSpPr>
          <p:spPr>
            <a:xfrm>
              <a:off x="4216320" y="4458600"/>
              <a:ext cx="39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GS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ZoneTexte 107"/>
            <p:cNvSpPr/>
            <p:nvPr/>
          </p:nvSpPr>
          <p:spPr>
            <a:xfrm>
              <a:off x="4794480" y="4458600"/>
              <a:ext cx="676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GST E2F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Connecteur droit 108"/>
            <p:cNvSpPr/>
            <p:nvPr/>
          </p:nvSpPr>
          <p:spPr>
            <a:xfrm>
              <a:off x="4601520" y="4674960"/>
              <a:ext cx="1002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Connecteur droit 109"/>
            <p:cNvSpPr/>
            <p:nvPr/>
          </p:nvSpPr>
          <p:spPr>
            <a:xfrm flipH="1" flipV="1">
              <a:off x="4256640" y="4674600"/>
              <a:ext cx="250560" cy="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ZoneTexte 110"/>
            <p:cNvSpPr/>
            <p:nvPr/>
          </p:nvSpPr>
          <p:spPr>
            <a:xfrm>
              <a:off x="4278600" y="4619520"/>
              <a:ext cx="147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-   +   -  +  +   +   +   +   + 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-   +   -   -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Triangle rectangle 111"/>
            <p:cNvSpPr/>
            <p:nvPr/>
          </p:nvSpPr>
          <p:spPr>
            <a:xfrm flipH="1">
              <a:off x="4851360" y="4845960"/>
              <a:ext cx="720720" cy="45720"/>
            </a:xfrm>
            <a:prstGeom prst="rtTriangl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0" name="Picture 2" descr=""/>
            <p:cNvPicPr/>
            <p:nvPr/>
          </p:nvPicPr>
          <p:blipFill>
            <a:blip r:embed="rId13">
              <a:lum bright="12000"/>
            </a:blip>
            <a:stretch/>
          </p:blipFill>
          <p:spPr>
            <a:xfrm>
              <a:off x="4225320" y="4970160"/>
              <a:ext cx="1378800" cy="176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01" name="Picture 3" descr=""/>
            <p:cNvPicPr/>
            <p:nvPr/>
          </p:nvPicPr>
          <p:blipFill>
            <a:blip r:embed="rId14"/>
            <a:srcRect l="26152" t="0" r="5905" b="4153"/>
            <a:stretch/>
          </p:blipFill>
          <p:spPr>
            <a:xfrm>
              <a:off x="4789440" y="6113520"/>
              <a:ext cx="814680" cy="176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02" name="Picture 2" descr=""/>
            <p:cNvPicPr/>
            <p:nvPr/>
          </p:nvPicPr>
          <p:blipFill>
            <a:blip r:embed="rId15"/>
            <a:stretch/>
          </p:blipFill>
          <p:spPr>
            <a:xfrm>
              <a:off x="4225320" y="5206320"/>
              <a:ext cx="1378800" cy="176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03" name="Picture 6" descr=""/>
            <p:cNvPicPr/>
            <p:nvPr/>
          </p:nvPicPr>
          <p:blipFill>
            <a:blip r:embed="rId16"/>
            <a:stretch/>
          </p:blipFill>
          <p:spPr>
            <a:xfrm>
              <a:off x="4225320" y="5442120"/>
              <a:ext cx="1378800" cy="176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04" name="Picture 7" descr=""/>
            <p:cNvPicPr/>
            <p:nvPr/>
          </p:nvPicPr>
          <p:blipFill>
            <a:blip r:embed="rId17"/>
            <a:stretch/>
          </p:blipFill>
          <p:spPr>
            <a:xfrm flipH="1">
              <a:off x="4224960" y="5677560"/>
              <a:ext cx="344520" cy="1472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05" name="Picture 8" descr=""/>
            <p:cNvPicPr/>
            <p:nvPr/>
          </p:nvPicPr>
          <p:blipFill>
            <a:blip r:embed="rId18"/>
            <a:stretch/>
          </p:blipFill>
          <p:spPr>
            <a:xfrm>
              <a:off x="4789440" y="5877720"/>
              <a:ext cx="814680" cy="176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206" name="Connecteur droit 118"/>
            <p:cNvSpPr/>
            <p:nvPr/>
          </p:nvSpPr>
          <p:spPr>
            <a:xfrm>
              <a:off x="3522960" y="5907240"/>
              <a:ext cx="0" cy="35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Connecteur droit 119"/>
            <p:cNvSpPr/>
            <p:nvPr/>
          </p:nvSpPr>
          <p:spPr>
            <a:xfrm>
              <a:off x="3522960" y="4939560"/>
              <a:ext cx="0" cy="84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ZoneTexte 120"/>
            <p:cNvSpPr/>
            <p:nvPr/>
          </p:nvSpPr>
          <p:spPr>
            <a:xfrm flipH="1" flipV="1" rot="5400000">
              <a:off x="3048840" y="5268600"/>
              <a:ext cx="71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Helvetica LT Std"/>
                  <a:ea typeface="Arial"/>
                </a:rPr>
                <a:t>Pull-dow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ZoneTexte 121"/>
            <p:cNvSpPr/>
            <p:nvPr/>
          </p:nvSpPr>
          <p:spPr>
            <a:xfrm>
              <a:off x="3195360" y="4286160"/>
              <a:ext cx="829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Helvetica LT Std"/>
                </a:rPr>
                <a:t>D. </a:t>
              </a:r>
              <a:r>
                <a:rPr b="0" lang="fr-FR" sz="1100" spc="-1" strike="noStrike">
                  <a:solidFill>
                    <a:srgbClr val="000000"/>
                  </a:solidFill>
                  <a:latin typeface="Helvetica LT Std"/>
                </a:rPr>
                <a:t>HeLa</a:t>
              </a:r>
              <a:r>
                <a:rPr b="1" lang="fr-FR" sz="1600" spc="-1" strike="noStrike">
                  <a:solidFill>
                    <a:srgbClr val="000000"/>
                  </a:solidFill>
                  <a:latin typeface="Helvetica LT Std"/>
                </a:rPr>
                <a:t>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10" name="Groupe 122"/>
            <p:cNvGrpSpPr/>
            <p:nvPr/>
          </p:nvGrpSpPr>
          <p:grpSpPr>
            <a:xfrm>
              <a:off x="5599800" y="4952880"/>
              <a:ext cx="331560" cy="200520"/>
              <a:chOff x="5599800" y="4952880"/>
              <a:chExt cx="331560" cy="200520"/>
            </a:xfrm>
          </p:grpSpPr>
          <p:sp>
            <p:nvSpPr>
              <p:cNvPr id="211" name="Connecteur droit 138"/>
              <p:cNvSpPr/>
              <p:nvPr/>
            </p:nvSpPr>
            <p:spPr>
              <a:xfrm>
                <a:off x="5625360" y="50655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ZoneTexte 139"/>
              <p:cNvSpPr/>
              <p:nvPr/>
            </p:nvSpPr>
            <p:spPr>
              <a:xfrm>
                <a:off x="5599800" y="4952880"/>
                <a:ext cx="331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11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13" name="Groupe 123"/>
            <p:cNvGrpSpPr/>
            <p:nvPr/>
          </p:nvGrpSpPr>
          <p:grpSpPr>
            <a:xfrm>
              <a:off x="5595120" y="5205960"/>
              <a:ext cx="281160" cy="200520"/>
              <a:chOff x="5595120" y="5205960"/>
              <a:chExt cx="281160" cy="200520"/>
            </a:xfrm>
          </p:grpSpPr>
          <p:sp>
            <p:nvSpPr>
              <p:cNvPr id="214" name="Connecteur droit 136"/>
              <p:cNvSpPr/>
              <p:nvPr/>
            </p:nvSpPr>
            <p:spPr>
              <a:xfrm>
                <a:off x="5620320" y="531864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ZoneTexte 137"/>
              <p:cNvSpPr/>
              <p:nvPr/>
            </p:nvSpPr>
            <p:spPr>
              <a:xfrm>
                <a:off x="5595120" y="5205960"/>
                <a:ext cx="28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7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16" name="Groupe 124"/>
            <p:cNvGrpSpPr/>
            <p:nvPr/>
          </p:nvGrpSpPr>
          <p:grpSpPr>
            <a:xfrm>
              <a:off x="5596560" y="5406840"/>
              <a:ext cx="281160" cy="200520"/>
              <a:chOff x="5596560" y="5406840"/>
              <a:chExt cx="281160" cy="200520"/>
            </a:xfrm>
          </p:grpSpPr>
          <p:sp>
            <p:nvSpPr>
              <p:cNvPr id="217" name="Connecteur droit 134"/>
              <p:cNvSpPr/>
              <p:nvPr/>
            </p:nvSpPr>
            <p:spPr>
              <a:xfrm>
                <a:off x="5621760" y="551952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ZoneTexte 135"/>
              <p:cNvSpPr/>
              <p:nvPr/>
            </p:nvSpPr>
            <p:spPr>
              <a:xfrm>
                <a:off x="5596560" y="5406840"/>
                <a:ext cx="28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8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19" name="Groupe 125"/>
            <p:cNvGrpSpPr/>
            <p:nvPr/>
          </p:nvGrpSpPr>
          <p:grpSpPr>
            <a:xfrm>
              <a:off x="5600160" y="5644080"/>
              <a:ext cx="281160" cy="200520"/>
              <a:chOff x="5600160" y="5644080"/>
              <a:chExt cx="281160" cy="200520"/>
            </a:xfrm>
          </p:grpSpPr>
          <p:sp>
            <p:nvSpPr>
              <p:cNvPr id="220" name="Connecteur droit 132"/>
              <p:cNvSpPr/>
              <p:nvPr/>
            </p:nvSpPr>
            <p:spPr>
              <a:xfrm>
                <a:off x="5625360" y="575676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ZoneTexte 133"/>
              <p:cNvSpPr/>
              <p:nvPr/>
            </p:nvSpPr>
            <p:spPr>
              <a:xfrm>
                <a:off x="5600160" y="5644080"/>
                <a:ext cx="28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2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2" name="Groupe 126"/>
            <p:cNvGrpSpPr/>
            <p:nvPr/>
          </p:nvGrpSpPr>
          <p:grpSpPr>
            <a:xfrm>
              <a:off x="5598720" y="5850720"/>
              <a:ext cx="331560" cy="200520"/>
              <a:chOff x="5598720" y="5850720"/>
              <a:chExt cx="331560" cy="200520"/>
            </a:xfrm>
          </p:grpSpPr>
          <p:sp>
            <p:nvSpPr>
              <p:cNvPr id="223" name="Connecteur droit 130"/>
              <p:cNvSpPr/>
              <p:nvPr/>
            </p:nvSpPr>
            <p:spPr>
              <a:xfrm>
                <a:off x="5624280" y="596340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ZoneTexte 131"/>
              <p:cNvSpPr/>
              <p:nvPr/>
            </p:nvSpPr>
            <p:spPr>
              <a:xfrm>
                <a:off x="5598720" y="5850720"/>
                <a:ext cx="331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11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5" name="Groupe 127"/>
            <p:cNvGrpSpPr/>
            <p:nvPr/>
          </p:nvGrpSpPr>
          <p:grpSpPr>
            <a:xfrm>
              <a:off x="5600160" y="6094440"/>
              <a:ext cx="281160" cy="200520"/>
              <a:chOff x="5600160" y="6094440"/>
              <a:chExt cx="281160" cy="200520"/>
            </a:xfrm>
          </p:grpSpPr>
          <p:sp>
            <p:nvSpPr>
              <p:cNvPr id="226" name="Connecteur droit 128"/>
              <p:cNvSpPr/>
              <p:nvPr/>
            </p:nvSpPr>
            <p:spPr>
              <a:xfrm>
                <a:off x="5625360" y="6207120"/>
                <a:ext cx="3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ZoneTexte 129"/>
              <p:cNvSpPr/>
              <p:nvPr/>
            </p:nvSpPr>
            <p:spPr>
              <a:xfrm>
                <a:off x="5600160" y="6094440"/>
                <a:ext cx="28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Helvetica LT Std"/>
                  </a:rPr>
                  <a:t>7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04T17:07:08Z</dcterms:created>
  <dc:creator>Laurence</dc:creator>
  <dc:description/>
  <dc:language>en-US</dc:language>
  <cp:lastModifiedBy>vidya.p</cp:lastModifiedBy>
  <cp:lastPrinted>2017-01-05T11:03:38Z</cp:lastPrinted>
  <dcterms:modified xsi:type="dcterms:W3CDTF">2017-05-19T11:36:43Z</dcterms:modified>
  <cp:revision>24</cp:revision>
  <dc:subject/>
  <dc:title>Présentation PowerPoint</dc:title>
</cp:coreProperties>
</file>